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76" r:id="rId1"/>
  </p:sldMasterIdLst>
  <p:sldIdLst>
    <p:sldId id="256" r:id="rId2"/>
  </p:sldIdLst>
  <p:sldSz cx="3200400" cy="379412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1211" autoAdjust="0"/>
    <p:restoredTop sz="94660"/>
  </p:normalViewPr>
  <p:slideViewPr>
    <p:cSldViewPr snapToGrid="0">
      <p:cViewPr varScale="1">
        <p:scale>
          <a:sx n="205" d="100"/>
          <a:sy n="205" d="100"/>
        </p:scale>
        <p:origin x="1504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40030" y="620937"/>
            <a:ext cx="2720340" cy="1320918"/>
          </a:xfrm>
        </p:spPr>
        <p:txBody>
          <a:bodyPr anchor="b"/>
          <a:lstStyle>
            <a:lvl1pPr algn="ctr">
              <a:defRPr sz="2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400050" y="1992794"/>
            <a:ext cx="2400300" cy="916035"/>
          </a:xfrm>
        </p:spPr>
        <p:txBody>
          <a:bodyPr/>
          <a:lstStyle>
            <a:lvl1pPr marL="0" indent="0" algn="ctr">
              <a:buNone/>
              <a:defRPr sz="840"/>
            </a:lvl1pPr>
            <a:lvl2pPr marL="160020" indent="0" algn="ctr">
              <a:buNone/>
              <a:defRPr sz="700"/>
            </a:lvl2pPr>
            <a:lvl3pPr marL="320040" indent="0" algn="ctr">
              <a:buNone/>
              <a:defRPr sz="630"/>
            </a:lvl3pPr>
            <a:lvl4pPr marL="480060" indent="0" algn="ctr">
              <a:buNone/>
              <a:defRPr sz="560"/>
            </a:lvl4pPr>
            <a:lvl5pPr marL="640080" indent="0" algn="ctr">
              <a:buNone/>
              <a:defRPr sz="560"/>
            </a:lvl5pPr>
            <a:lvl6pPr marL="800100" indent="0" algn="ctr">
              <a:buNone/>
              <a:defRPr sz="560"/>
            </a:lvl6pPr>
            <a:lvl7pPr marL="960120" indent="0" algn="ctr">
              <a:buNone/>
              <a:defRPr sz="560"/>
            </a:lvl7pPr>
            <a:lvl8pPr marL="1120140" indent="0" algn="ctr">
              <a:buNone/>
              <a:defRPr sz="560"/>
            </a:lvl8pPr>
            <a:lvl9pPr marL="1280160" indent="0" algn="ctr">
              <a:buNone/>
              <a:defRPr sz="5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51989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94893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290287" y="202002"/>
            <a:ext cx="690086" cy="321534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20028" y="202002"/>
            <a:ext cx="2030254" cy="3215346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096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38198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8361" y="945898"/>
            <a:ext cx="2760345" cy="1578250"/>
          </a:xfrm>
        </p:spPr>
        <p:txBody>
          <a:bodyPr anchor="b"/>
          <a:lstStyle>
            <a:lvl1pPr>
              <a:defRPr sz="21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8361" y="2539079"/>
            <a:ext cx="2760345" cy="829965"/>
          </a:xfrm>
        </p:spPr>
        <p:txBody>
          <a:bodyPr/>
          <a:lstStyle>
            <a:lvl1pPr marL="0" indent="0">
              <a:buNone/>
              <a:defRPr sz="840">
                <a:solidFill>
                  <a:schemeClr val="tx1"/>
                </a:solidFill>
              </a:defRPr>
            </a:lvl1pPr>
            <a:lvl2pPr marL="160020" indent="0">
              <a:buNone/>
              <a:defRPr sz="700">
                <a:solidFill>
                  <a:schemeClr val="tx1">
                    <a:tint val="75000"/>
                  </a:schemeClr>
                </a:solidFill>
              </a:defRPr>
            </a:lvl2pPr>
            <a:lvl3pPr marL="320040" indent="0">
              <a:buNone/>
              <a:defRPr sz="630">
                <a:solidFill>
                  <a:schemeClr val="tx1">
                    <a:tint val="75000"/>
                  </a:schemeClr>
                </a:solidFill>
              </a:defRPr>
            </a:lvl3pPr>
            <a:lvl4pPr marL="48006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4pPr>
            <a:lvl5pPr marL="64008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5pPr>
            <a:lvl6pPr marL="80010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6pPr>
            <a:lvl7pPr marL="96012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7pPr>
            <a:lvl8pPr marL="112014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8pPr>
            <a:lvl9pPr marL="1280160" indent="0">
              <a:buNone/>
              <a:defRPr sz="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0764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20028" y="1010010"/>
            <a:ext cx="1360170" cy="240733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620203" y="1010010"/>
            <a:ext cx="1360170" cy="2407337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99181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444" y="202003"/>
            <a:ext cx="2760345" cy="73335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445" y="930088"/>
            <a:ext cx="1353919" cy="455822"/>
          </a:xfrm>
        </p:spPr>
        <p:txBody>
          <a:bodyPr anchor="b"/>
          <a:lstStyle>
            <a:lvl1pPr marL="0" indent="0">
              <a:buNone/>
              <a:defRPr sz="840" b="1"/>
            </a:lvl1pPr>
            <a:lvl2pPr marL="160020" indent="0">
              <a:buNone/>
              <a:defRPr sz="700" b="1"/>
            </a:lvl2pPr>
            <a:lvl3pPr marL="320040" indent="0">
              <a:buNone/>
              <a:defRPr sz="630" b="1"/>
            </a:lvl3pPr>
            <a:lvl4pPr marL="480060" indent="0">
              <a:buNone/>
              <a:defRPr sz="560" b="1"/>
            </a:lvl4pPr>
            <a:lvl5pPr marL="640080" indent="0">
              <a:buNone/>
              <a:defRPr sz="560" b="1"/>
            </a:lvl5pPr>
            <a:lvl6pPr marL="800100" indent="0">
              <a:buNone/>
              <a:defRPr sz="560" b="1"/>
            </a:lvl6pPr>
            <a:lvl7pPr marL="960120" indent="0">
              <a:buNone/>
              <a:defRPr sz="560" b="1"/>
            </a:lvl7pPr>
            <a:lvl8pPr marL="1120140" indent="0">
              <a:buNone/>
              <a:defRPr sz="560" b="1"/>
            </a:lvl8pPr>
            <a:lvl9pPr marL="1280160" indent="0">
              <a:buNone/>
              <a:defRPr sz="5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20445" y="1385910"/>
            <a:ext cx="1353919" cy="20384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620203" y="930088"/>
            <a:ext cx="1360587" cy="455822"/>
          </a:xfrm>
        </p:spPr>
        <p:txBody>
          <a:bodyPr anchor="b"/>
          <a:lstStyle>
            <a:lvl1pPr marL="0" indent="0">
              <a:buNone/>
              <a:defRPr sz="840" b="1"/>
            </a:lvl1pPr>
            <a:lvl2pPr marL="160020" indent="0">
              <a:buNone/>
              <a:defRPr sz="700" b="1"/>
            </a:lvl2pPr>
            <a:lvl3pPr marL="320040" indent="0">
              <a:buNone/>
              <a:defRPr sz="630" b="1"/>
            </a:lvl3pPr>
            <a:lvl4pPr marL="480060" indent="0">
              <a:buNone/>
              <a:defRPr sz="560" b="1"/>
            </a:lvl4pPr>
            <a:lvl5pPr marL="640080" indent="0">
              <a:buNone/>
              <a:defRPr sz="560" b="1"/>
            </a:lvl5pPr>
            <a:lvl6pPr marL="800100" indent="0">
              <a:buNone/>
              <a:defRPr sz="560" b="1"/>
            </a:lvl6pPr>
            <a:lvl7pPr marL="960120" indent="0">
              <a:buNone/>
              <a:defRPr sz="560" b="1"/>
            </a:lvl7pPr>
            <a:lvl8pPr marL="1120140" indent="0">
              <a:buNone/>
              <a:defRPr sz="560" b="1"/>
            </a:lvl8pPr>
            <a:lvl9pPr marL="1280160" indent="0">
              <a:buNone/>
              <a:defRPr sz="5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620203" y="1385910"/>
            <a:ext cx="1360587" cy="203846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7157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3137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8651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445" y="252942"/>
            <a:ext cx="1032212" cy="885296"/>
          </a:xfrm>
        </p:spPr>
        <p:txBody>
          <a:bodyPr anchor="b"/>
          <a:lstStyle>
            <a:lvl1pPr>
              <a:defRPr sz="1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60587" y="546285"/>
            <a:ext cx="1620203" cy="2696288"/>
          </a:xfrm>
        </p:spPr>
        <p:txBody>
          <a:bodyPr/>
          <a:lstStyle>
            <a:lvl1pPr>
              <a:defRPr sz="1120"/>
            </a:lvl1pPr>
            <a:lvl2pPr>
              <a:defRPr sz="980"/>
            </a:lvl2pPr>
            <a:lvl3pPr>
              <a:defRPr sz="840"/>
            </a:lvl3pPr>
            <a:lvl4pPr>
              <a:defRPr sz="700"/>
            </a:lvl4pPr>
            <a:lvl5pPr>
              <a:defRPr sz="700"/>
            </a:lvl5pPr>
            <a:lvl6pPr>
              <a:defRPr sz="700"/>
            </a:lvl6pPr>
            <a:lvl7pPr>
              <a:defRPr sz="700"/>
            </a:lvl7pPr>
            <a:lvl8pPr>
              <a:defRPr sz="700"/>
            </a:lvl8pPr>
            <a:lvl9pPr>
              <a:defRPr sz="7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0445" y="1138237"/>
            <a:ext cx="1032212" cy="2108726"/>
          </a:xfrm>
        </p:spPr>
        <p:txBody>
          <a:bodyPr/>
          <a:lstStyle>
            <a:lvl1pPr marL="0" indent="0">
              <a:buNone/>
              <a:defRPr sz="560"/>
            </a:lvl1pPr>
            <a:lvl2pPr marL="160020" indent="0">
              <a:buNone/>
              <a:defRPr sz="490"/>
            </a:lvl2pPr>
            <a:lvl3pPr marL="320040" indent="0">
              <a:buNone/>
              <a:defRPr sz="420"/>
            </a:lvl3pPr>
            <a:lvl4pPr marL="480060" indent="0">
              <a:buNone/>
              <a:defRPr sz="350"/>
            </a:lvl4pPr>
            <a:lvl5pPr marL="640080" indent="0">
              <a:buNone/>
              <a:defRPr sz="350"/>
            </a:lvl5pPr>
            <a:lvl6pPr marL="800100" indent="0">
              <a:buNone/>
              <a:defRPr sz="350"/>
            </a:lvl6pPr>
            <a:lvl7pPr marL="960120" indent="0">
              <a:buNone/>
              <a:defRPr sz="350"/>
            </a:lvl7pPr>
            <a:lvl8pPr marL="1120140" indent="0">
              <a:buNone/>
              <a:defRPr sz="350"/>
            </a:lvl8pPr>
            <a:lvl9pPr marL="1280160" indent="0">
              <a:buNone/>
              <a:defRPr sz="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9285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20445" y="252942"/>
            <a:ext cx="1032212" cy="885296"/>
          </a:xfrm>
        </p:spPr>
        <p:txBody>
          <a:bodyPr anchor="b"/>
          <a:lstStyle>
            <a:lvl1pPr>
              <a:defRPr sz="1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60587" y="546285"/>
            <a:ext cx="1620203" cy="2696288"/>
          </a:xfrm>
        </p:spPr>
        <p:txBody>
          <a:bodyPr anchor="t"/>
          <a:lstStyle>
            <a:lvl1pPr marL="0" indent="0">
              <a:buNone/>
              <a:defRPr sz="1120"/>
            </a:lvl1pPr>
            <a:lvl2pPr marL="160020" indent="0">
              <a:buNone/>
              <a:defRPr sz="980"/>
            </a:lvl2pPr>
            <a:lvl3pPr marL="320040" indent="0">
              <a:buNone/>
              <a:defRPr sz="840"/>
            </a:lvl3pPr>
            <a:lvl4pPr marL="480060" indent="0">
              <a:buNone/>
              <a:defRPr sz="700"/>
            </a:lvl4pPr>
            <a:lvl5pPr marL="640080" indent="0">
              <a:buNone/>
              <a:defRPr sz="700"/>
            </a:lvl5pPr>
            <a:lvl6pPr marL="800100" indent="0">
              <a:buNone/>
              <a:defRPr sz="700"/>
            </a:lvl6pPr>
            <a:lvl7pPr marL="960120" indent="0">
              <a:buNone/>
              <a:defRPr sz="700"/>
            </a:lvl7pPr>
            <a:lvl8pPr marL="1120140" indent="0">
              <a:buNone/>
              <a:defRPr sz="700"/>
            </a:lvl8pPr>
            <a:lvl9pPr marL="1280160" indent="0">
              <a:buNone/>
              <a:defRPr sz="7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20445" y="1138237"/>
            <a:ext cx="1032212" cy="2108726"/>
          </a:xfrm>
        </p:spPr>
        <p:txBody>
          <a:bodyPr/>
          <a:lstStyle>
            <a:lvl1pPr marL="0" indent="0">
              <a:buNone/>
              <a:defRPr sz="560"/>
            </a:lvl1pPr>
            <a:lvl2pPr marL="160020" indent="0">
              <a:buNone/>
              <a:defRPr sz="490"/>
            </a:lvl2pPr>
            <a:lvl3pPr marL="320040" indent="0">
              <a:buNone/>
              <a:defRPr sz="420"/>
            </a:lvl3pPr>
            <a:lvl4pPr marL="480060" indent="0">
              <a:buNone/>
              <a:defRPr sz="350"/>
            </a:lvl4pPr>
            <a:lvl5pPr marL="640080" indent="0">
              <a:buNone/>
              <a:defRPr sz="350"/>
            </a:lvl5pPr>
            <a:lvl6pPr marL="800100" indent="0">
              <a:buNone/>
              <a:defRPr sz="350"/>
            </a:lvl6pPr>
            <a:lvl7pPr marL="960120" indent="0">
              <a:buNone/>
              <a:defRPr sz="350"/>
            </a:lvl7pPr>
            <a:lvl8pPr marL="1120140" indent="0">
              <a:buNone/>
              <a:defRPr sz="350"/>
            </a:lvl8pPr>
            <a:lvl9pPr marL="1280160" indent="0">
              <a:buNone/>
              <a:defRPr sz="3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961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20028" y="202003"/>
            <a:ext cx="2760345" cy="7333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20028" y="1010010"/>
            <a:ext cx="2760345" cy="2407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20028" y="3516593"/>
            <a:ext cx="720090" cy="2020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3969D3-BF29-4C15-86E3-E82E11DDCA9B}" type="datetimeFigureOut">
              <a:rPr lang="en-US" smtClean="0"/>
              <a:t>7/7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60133" y="3516593"/>
            <a:ext cx="1080135" cy="2020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260283" y="3516593"/>
            <a:ext cx="720090" cy="2020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CC16C8-680E-4384-80A0-FF63A42D32A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78164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77" r:id="rId1"/>
    <p:sldLayoutId id="2147483878" r:id="rId2"/>
    <p:sldLayoutId id="2147483879" r:id="rId3"/>
    <p:sldLayoutId id="2147483880" r:id="rId4"/>
    <p:sldLayoutId id="2147483881" r:id="rId5"/>
    <p:sldLayoutId id="2147483882" r:id="rId6"/>
    <p:sldLayoutId id="2147483883" r:id="rId7"/>
    <p:sldLayoutId id="2147483884" r:id="rId8"/>
    <p:sldLayoutId id="2147483885" r:id="rId9"/>
    <p:sldLayoutId id="2147483886" r:id="rId10"/>
    <p:sldLayoutId id="2147483887" r:id="rId11"/>
  </p:sldLayoutIdLst>
  <p:txStyles>
    <p:titleStyle>
      <a:lvl1pPr algn="l" defTabSz="320040" rtl="0" eaLnBrk="1" latinLnBrk="0" hangingPunct="1">
        <a:lnSpc>
          <a:spcPct val="90000"/>
        </a:lnSpc>
        <a:spcBef>
          <a:spcPct val="0"/>
        </a:spcBef>
        <a:buNone/>
        <a:defRPr sz="15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80010" indent="-80010" algn="l" defTabSz="320040" rtl="0" eaLnBrk="1" latinLnBrk="0" hangingPunct="1">
        <a:lnSpc>
          <a:spcPct val="90000"/>
        </a:lnSpc>
        <a:spcBef>
          <a:spcPts val="350"/>
        </a:spcBef>
        <a:buFont typeface="Arial" panose="020B0604020202020204" pitchFamily="34" charset="0"/>
        <a:buChar char="•"/>
        <a:defRPr sz="980" kern="1200">
          <a:solidFill>
            <a:schemeClr val="tx1"/>
          </a:solidFill>
          <a:latin typeface="+mn-lt"/>
          <a:ea typeface="+mn-ea"/>
          <a:cs typeface="+mn-cs"/>
        </a:defRPr>
      </a:lvl1pPr>
      <a:lvl2pPr marL="24003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840" kern="1200">
          <a:solidFill>
            <a:schemeClr val="tx1"/>
          </a:solidFill>
          <a:latin typeface="+mn-lt"/>
          <a:ea typeface="+mn-ea"/>
          <a:cs typeface="+mn-cs"/>
        </a:defRPr>
      </a:lvl2pPr>
      <a:lvl3pPr marL="40005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700" kern="1200">
          <a:solidFill>
            <a:schemeClr val="tx1"/>
          </a:solidFill>
          <a:latin typeface="+mn-lt"/>
          <a:ea typeface="+mn-ea"/>
          <a:cs typeface="+mn-cs"/>
        </a:defRPr>
      </a:lvl3pPr>
      <a:lvl4pPr marL="56007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4pPr>
      <a:lvl5pPr marL="72009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5pPr>
      <a:lvl6pPr marL="88011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6pPr>
      <a:lvl7pPr marL="104013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7pPr>
      <a:lvl8pPr marL="120015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8pPr>
      <a:lvl9pPr marL="1360170" indent="-80010" algn="l" defTabSz="320040" rtl="0" eaLnBrk="1" latinLnBrk="0" hangingPunct="1">
        <a:lnSpc>
          <a:spcPct val="90000"/>
        </a:lnSpc>
        <a:spcBef>
          <a:spcPts val="175"/>
        </a:spcBef>
        <a:buFont typeface="Arial" panose="020B0604020202020204" pitchFamily="34" charset="0"/>
        <a:buChar char="•"/>
        <a:defRPr sz="6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1pPr>
      <a:lvl2pPr marL="16002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2pPr>
      <a:lvl3pPr marL="32004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4pPr>
      <a:lvl5pPr marL="64008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5pPr>
      <a:lvl6pPr marL="80010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6pPr>
      <a:lvl7pPr marL="96012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7pPr>
      <a:lvl8pPr marL="112014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8pPr>
      <a:lvl9pPr marL="1280160" algn="l" defTabSz="320040" rtl="0" eaLnBrk="1" latinLnBrk="0" hangingPunct="1">
        <a:defRPr sz="6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1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13738" y="2956766"/>
            <a:ext cx="3178509" cy="84246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801" b="1" dirty="0">
                <a:latin typeface="Times New Roman" panose="02020603050405020304" pitchFamily="18" charset="0"/>
                <a:ea typeface="Yu Mincho" panose="02020400000000000000" pitchFamily="18" charset="-128"/>
              </a:rPr>
              <a:t>Figure S1. </a:t>
            </a:r>
            <a:r>
              <a:rPr lang="en-US" sz="801" dirty="0">
                <a:latin typeface="Times New Roman" panose="02020603050405020304" pitchFamily="18" charset="0"/>
                <a:ea typeface="Yu Mincho" panose="02020400000000000000" pitchFamily="18" charset="-128"/>
              </a:rPr>
              <a:t>Effects of ligand treatment on the expression of LPHNs. Western blotting of LPHN1 and LPHN2 in SVHUC cells cultured for 48 hours with ethanol (mock), 0.1 </a:t>
            </a:r>
            <a:r>
              <a:rPr lang="en-US" sz="801" dirty="0" err="1">
                <a:latin typeface="Times New Roman" panose="02020603050405020304" pitchFamily="18" charset="0"/>
                <a:ea typeface="Yu Mincho" panose="02020400000000000000" pitchFamily="18" charset="-128"/>
              </a:rPr>
              <a:t>nM</a:t>
            </a:r>
            <a:r>
              <a:rPr lang="en-US" sz="801" dirty="0">
                <a:latin typeface="Times New Roman" panose="02020603050405020304" pitchFamily="18" charset="0"/>
                <a:ea typeface="Yu Mincho" panose="02020400000000000000" pitchFamily="18" charset="-128"/>
              </a:rPr>
              <a:t> α-LTX, or 0.175 </a:t>
            </a:r>
            <a:r>
              <a:rPr lang="en-US" sz="801" dirty="0" err="1">
                <a:latin typeface="Times New Roman" panose="02020603050405020304" pitchFamily="18" charset="0"/>
                <a:ea typeface="Yu Mincho" panose="02020400000000000000" pitchFamily="18" charset="-128"/>
              </a:rPr>
              <a:t>nM</a:t>
            </a:r>
            <a:r>
              <a:rPr lang="en-US" sz="801" dirty="0">
                <a:latin typeface="Times New Roman" panose="02020603050405020304" pitchFamily="18" charset="0"/>
                <a:ea typeface="Yu Mincho" panose="02020400000000000000" pitchFamily="18" charset="-128"/>
              </a:rPr>
              <a:t> FLRT3. GAPDH served as a loading control. </a:t>
            </a:r>
            <a:r>
              <a:rPr lang="en-US" sz="8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densitometry values for LPHN1 and LPHN2, normalized by GAPDH and expressed relative to mock treatment, are included below the lanes</a:t>
            </a:r>
            <a:r>
              <a:rPr lang="en-US" sz="80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8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5"/>
          <p:cNvGrpSpPr/>
          <p:nvPr/>
        </p:nvGrpSpPr>
        <p:grpSpPr>
          <a:xfrm>
            <a:off x="5849" y="16721"/>
            <a:ext cx="3143398" cy="2857840"/>
            <a:chOff x="5849" y="16721"/>
            <a:chExt cx="3143398" cy="2857840"/>
          </a:xfrm>
        </p:grpSpPr>
        <p:sp>
          <p:nvSpPr>
            <p:cNvPr id="58" name="Rectangle 57"/>
            <p:cNvSpPr/>
            <p:nvPr/>
          </p:nvSpPr>
          <p:spPr>
            <a:xfrm>
              <a:off x="5849" y="2402712"/>
              <a:ext cx="785408" cy="2808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GAPDH</a:t>
              </a:r>
              <a:endParaRPr lang="en-US" sz="1200" dirty="0"/>
            </a:p>
          </p:txBody>
        </p:sp>
        <p:sp>
          <p:nvSpPr>
            <p:cNvPr id="59" name="Rectangle 58"/>
            <p:cNvSpPr/>
            <p:nvPr/>
          </p:nvSpPr>
          <p:spPr>
            <a:xfrm>
              <a:off x="14452" y="512329"/>
              <a:ext cx="785408" cy="2808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LPHN1</a:t>
              </a:r>
              <a:endParaRPr lang="en-US" sz="1200" dirty="0"/>
            </a:p>
          </p:txBody>
        </p:sp>
        <p:sp>
          <p:nvSpPr>
            <p:cNvPr id="71" name="Rectangle 70"/>
            <p:cNvSpPr/>
            <p:nvPr/>
          </p:nvSpPr>
          <p:spPr>
            <a:xfrm>
              <a:off x="917981" y="19915"/>
              <a:ext cx="55294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mock</a:t>
              </a:r>
              <a:endParaRPr lang="en-US" sz="1200" dirty="0"/>
            </a:p>
          </p:txBody>
        </p:sp>
        <p:sp>
          <p:nvSpPr>
            <p:cNvPr id="72" name="Rectangle 71"/>
            <p:cNvSpPr/>
            <p:nvPr/>
          </p:nvSpPr>
          <p:spPr>
            <a:xfrm>
              <a:off x="1529447" y="20568"/>
              <a:ext cx="686089" cy="2808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l-GR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-LTX</a:t>
              </a:r>
              <a:endParaRPr lang="en-US" sz="1200" dirty="0"/>
            </a:p>
          </p:txBody>
        </p:sp>
        <p:sp>
          <p:nvSpPr>
            <p:cNvPr id="134" name="Rectangle 133"/>
            <p:cNvSpPr/>
            <p:nvPr/>
          </p:nvSpPr>
          <p:spPr>
            <a:xfrm>
              <a:off x="13725" y="1459141"/>
              <a:ext cx="785408" cy="2808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LPHN2</a:t>
              </a:r>
              <a:endParaRPr lang="en-US" sz="1200" dirty="0"/>
            </a:p>
          </p:txBody>
        </p:sp>
        <p:sp>
          <p:nvSpPr>
            <p:cNvPr id="63" name="Rectangle 62"/>
            <p:cNvSpPr/>
            <p:nvPr/>
          </p:nvSpPr>
          <p:spPr>
            <a:xfrm>
              <a:off x="2326233" y="16721"/>
              <a:ext cx="699322" cy="28082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>
                  <a:latin typeface="Arial" panose="020B0604020202020204" pitchFamily="34" charset="0"/>
                  <a:cs typeface="Arial" panose="020B0604020202020204" pitchFamily="34" charset="0"/>
                </a:rPr>
                <a:t>FLRT3</a:t>
              </a:r>
              <a:endParaRPr lang="en-US" sz="1200" dirty="0"/>
            </a:p>
          </p:txBody>
        </p:sp>
        <p:graphicFrame>
          <p:nvGraphicFramePr>
            <p:cNvPr id="4" name="Object 3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057600284"/>
                </p:ext>
              </p:extLst>
            </p:nvPr>
          </p:nvGraphicFramePr>
          <p:xfrm>
            <a:off x="802332" y="318871"/>
            <a:ext cx="2346915" cy="255569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32" name="Image" r:id="rId3" imgW="4114080" imgH="4482360" progId="Photoshop.Image.7">
                    <p:embed/>
                  </p:oleObj>
                </mc:Choice>
                <mc:Fallback>
                  <p:oleObj name="Image" r:id="rId3" imgW="4114080" imgH="4482360" progId="Photoshop.Image.7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802332" y="318871"/>
                          <a:ext cx="2346915" cy="255569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5" name="Rectangle 4"/>
            <p:cNvSpPr/>
            <p:nvPr/>
          </p:nvSpPr>
          <p:spPr>
            <a:xfrm>
              <a:off x="917982" y="931287"/>
              <a:ext cx="55294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endParaRPr lang="en-US" sz="1200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1596014" y="931287"/>
              <a:ext cx="55294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.90</a:t>
              </a:r>
              <a:endParaRPr lang="en-US" sz="1200" dirty="0"/>
            </a:p>
          </p:txBody>
        </p:sp>
        <p:sp>
          <p:nvSpPr>
            <p:cNvPr id="15" name="Rectangle 14"/>
            <p:cNvSpPr/>
            <p:nvPr/>
          </p:nvSpPr>
          <p:spPr>
            <a:xfrm>
              <a:off x="2399420" y="938011"/>
              <a:ext cx="55294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.42</a:t>
              </a:r>
              <a:endParaRPr lang="en-US" sz="1200" dirty="0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920115" y="1908562"/>
              <a:ext cx="55294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.00</a:t>
              </a:r>
              <a:endParaRPr lang="en-US" sz="1200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1559129" y="1908562"/>
              <a:ext cx="647678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9.87</a:t>
              </a:r>
              <a:endParaRPr lang="en-US" sz="1200" dirty="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2374340" y="1915286"/>
              <a:ext cx="626132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ja-JP" sz="1200" kern="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.14</a:t>
              </a:r>
              <a:endParaRPr lang="en-US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20291394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69</TotalTime>
  <Words>84</Words>
  <Application>Microsoft Office PowerPoint</Application>
  <PresentationFormat>Custom</PresentationFormat>
  <Paragraphs>13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游ゴシック</vt:lpstr>
      <vt:lpstr>Yu Mincho</vt:lpstr>
      <vt:lpstr>Arial</vt:lpstr>
      <vt:lpstr>Calibri</vt:lpstr>
      <vt:lpstr>Calibri Light</vt:lpstr>
      <vt:lpstr>Times New Roman</vt:lpstr>
      <vt:lpstr>Office Theme</vt:lpstr>
      <vt:lpstr>Image</vt:lpstr>
      <vt:lpstr>PowerPoint Presentation</vt:lpstr>
    </vt:vector>
  </TitlesOfParts>
  <Company>URM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yamoto, Hiroshi</dc:creator>
  <cp:lastModifiedBy>Miyamoto, Hiroshi</cp:lastModifiedBy>
  <cp:revision>32</cp:revision>
  <dcterms:created xsi:type="dcterms:W3CDTF">2024-03-08T16:47:08Z</dcterms:created>
  <dcterms:modified xsi:type="dcterms:W3CDTF">2026-07-07T12:03:13Z</dcterms:modified>
</cp:coreProperties>
</file>